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1" r:id="rId2"/>
    <p:sldId id="282" r:id="rId3"/>
    <p:sldId id="283" r:id="rId4"/>
    <p:sldId id="284" r:id="rId5"/>
    <p:sldId id="285" r:id="rId6"/>
    <p:sldId id="286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86" autoAdjust="0"/>
    <p:restoredTop sz="94660"/>
  </p:normalViewPr>
  <p:slideViewPr>
    <p:cSldViewPr snapToGrid="0">
      <p:cViewPr varScale="1">
        <p:scale>
          <a:sx n="49" d="100"/>
          <a:sy n="49" d="100"/>
        </p:scale>
        <p:origin x="14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3737E-70F0-422D-9199-817AAE48ECD4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814A7B-5258-405C-A7A7-6B9E308214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5501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768929-5334-426B-88F4-D45D47053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02F5513-A889-4B47-927A-45864B5488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E3B967-4EB1-4B5B-8723-9E3822A3C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2B9876-BC1B-4533-9AEF-A25FE8E84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C3652F-2F8D-41B4-A875-2ECFBD77C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132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8C062E-D1B0-4D17-ABCA-8A2C262FA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1932EAD-6AC8-43F0-8430-6105B37DAE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94CB32-1FB4-4496-8E28-9D6BD4907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C4316A-16B0-4181-8F26-66B594F70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7AC0A8-D9FD-4CDA-9FB6-30F27C00D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422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9315DC2-9A62-43A4-BA87-F22C770CB4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D77F197-ECC6-4D7D-87D2-84E780F80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90D7AC-8CC5-41F9-8429-52CF5640C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B414A1-5551-40FF-91C0-D71F20686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2A8614-1F28-4831-A9D2-832CF1F27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6763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DF19A4-EF35-4C9C-BEFD-CB125EEFF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67FE68-3D29-42DB-ABC4-E82D6478CB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001C8F-BC4B-42EE-9AF0-7F5645650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86DECA-3B97-45D4-8ACB-DB8E21112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ACCE80-25F3-4BDB-BDC4-680E0780A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5196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1AFEAB-20CF-4669-91D8-36FC9EC50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5A4E6B-6BF1-45F8-A32A-FF5C1316F1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5D5FFE-949A-4A70-8363-084E8EB28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86B7C0-CD54-46A8-97D2-22EECF3FD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2C3185-70A8-4130-B91F-915D1A6F6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246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BD85D5-B737-42E2-8884-048A0659B1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599E70F-B427-4AC9-9F2B-5B62711460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3007756-6CD9-4C57-97C8-A23F6218E6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13A34B-B92E-4DB1-B27A-DEFC4376F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2B4877-711D-4FF1-BC19-54421437C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D385A0-04EA-4162-979E-7F3C2CD84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9772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FC0168-D10B-434C-B946-F8674697E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F73844B-C409-4B3E-935A-D47C57172E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FB8E23-56EC-4CCD-AC89-061F0B09D5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1BA7F78-80E1-4B6A-86D6-8EE2CEBBDA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21568F9-2301-4949-BA68-B1CE049C9F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97EDE9F-9FD9-4BA1-B526-3D0777C4B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EE85471-56A6-42FC-B31A-EB6010753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02336B2-79C1-4BF8-B0D4-45D6B04F2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577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8CBB18-D439-45A6-8A11-AC2E74D354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E85A42B-C59D-4736-BA7E-71B807329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49E5788-1576-4B13-809B-B09071F72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98D6FD5-C4CC-41CE-88AF-5AF64CBB5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353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719FD24-7108-4BA7-8FE5-C39F3F482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6DD4081-0E70-40C3-BFA4-7BF990250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AEBFF96-3B3C-4EEA-A1E4-B3136134B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9855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7DE0C1-B4A2-4621-9969-FD4BE850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D2D80F-7E9D-455A-86B9-EF7312E941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14C674-72F6-4524-9462-93A100EB9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9CF052-44D1-487D-AD43-B078F9094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6E74629-2E7A-477F-AEFC-CD6060493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C447139-655B-4E0A-A44B-7213173A4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701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F4E416-C9F9-4F65-A1DF-E0403B9939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B7018CF-57BB-4F6F-A339-2F260BD10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0145F4B-D491-4AC7-8C2D-310DDC96F3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BFEE5BB-8327-4548-BBCA-3305B4716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2ECA85-DBEE-4095-86E7-34621E5EF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B85914-FF5C-4CE1-BC72-199EDCECD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0121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05A2146-F1AB-41AF-8AE7-E5A46E3CB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852D60-801B-44F5-B50D-BEB82F7D7C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E8AA6A-501F-4486-AAC0-5F5F9642D4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625BB-E665-49BC-A0AC-D7BB3ED92B38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22424C-A150-4FDC-B345-7E75E434BF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4B5381-6D4C-4705-ADB9-A5DBC891A8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CA87F-682C-41F9-87E2-02CEACB8B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553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94D5499-CE12-487C-F0CE-44ADA808770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736" t="828" b="15368"/>
          <a:stretch/>
        </p:blipFill>
        <p:spPr>
          <a:xfrm>
            <a:off x="2945146" y="726564"/>
            <a:ext cx="6765400" cy="4569476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8009704" cy="4988852"/>
            <a:chOff x="2520376" y="1521804"/>
            <a:chExt cx="6269332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 MACE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2008803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7274" y="3396950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6286335" y="2345151"/>
              <a:ext cx="2503373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= 0.0014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68204" y="1658479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26.8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17.8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BC502A1F-8119-4E7A-9CA2-426361B020B5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47" name="Rectangle 48">
              <a:extLst>
                <a:ext uri="{FF2B5EF4-FFF2-40B4-BE49-F238E27FC236}">
                  <a16:creationId xmlns:a16="http://schemas.microsoft.com/office/drawing/2014/main" id="{344C3B26-F14D-4AE6-B581-C3F0D742D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56">
              <a:extLst>
                <a:ext uri="{FF2B5EF4-FFF2-40B4-BE49-F238E27FC236}">
                  <a16:creationId xmlns:a16="http://schemas.microsoft.com/office/drawing/2014/main" id="{3C0385CA-0E67-4937-982C-8B739DA770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1 (Age &lt;64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B1BA4DE-E84F-56E7-3EDE-85F46FBB700F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1a</a:t>
            </a:r>
            <a:endParaRPr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958208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EFA554D-B2BA-B153-F03D-B6A8CB5584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744" b="15579"/>
          <a:stretch/>
        </p:blipFill>
        <p:spPr>
          <a:xfrm>
            <a:off x="2896370" y="611062"/>
            <a:ext cx="6814176" cy="4636683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7805279" cy="4988852"/>
            <a:chOff x="2520376" y="1521804"/>
            <a:chExt cx="6109325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 MACE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1977820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1499" y="3373714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6327080" y="2405085"/>
              <a:ext cx="2302621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= 0.34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68204" y="1658479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23.6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18.1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AF5E164-1420-AB47-3E19-35B2C2C0192E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1b</a:t>
            </a:r>
            <a:endParaRPr lang="ja-JP" altLang="en-US" sz="2400" b="1" dirty="0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910A22C-CB51-E7AF-3F75-55B412CA86AF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6" name="Rectangle 48">
              <a:extLst>
                <a:ext uri="{FF2B5EF4-FFF2-40B4-BE49-F238E27FC236}">
                  <a16:creationId xmlns:a16="http://schemas.microsoft.com/office/drawing/2014/main" id="{53CB7933-B7A5-80DA-222D-3E42CD51F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56">
              <a:extLst>
                <a:ext uri="{FF2B5EF4-FFF2-40B4-BE49-F238E27FC236}">
                  <a16:creationId xmlns:a16="http://schemas.microsoft.com/office/drawing/2014/main" id="{AAA6A843-D141-7B2D-2CA8-EB246E6F27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2 (Age 64-73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112284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0BBE451-B547-5F10-AAE0-D0F9A282C89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425" b="15826"/>
          <a:stretch/>
        </p:blipFill>
        <p:spPr>
          <a:xfrm>
            <a:off x="2905385" y="638698"/>
            <a:ext cx="6805161" cy="4599372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7876900" cy="4988852"/>
            <a:chOff x="2520376" y="1521804"/>
            <a:chExt cx="6165384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 MACE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1985565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7274" y="3381459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6282763" y="2410676"/>
              <a:ext cx="2402997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= 0.025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68204" y="1658479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25.9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23.3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FEA356E-183B-AF55-4F3F-76E8E81BE6B8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1c</a:t>
            </a:r>
            <a:endParaRPr lang="ja-JP" altLang="en-US" sz="2400" b="1" dirty="0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81A3BBF1-F105-FF1C-18E0-0102E529131E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6" name="Rectangle 48">
              <a:extLst>
                <a:ext uri="{FF2B5EF4-FFF2-40B4-BE49-F238E27FC236}">
                  <a16:creationId xmlns:a16="http://schemas.microsoft.com/office/drawing/2014/main" id="{B39CEB8E-F2B6-C50A-64E2-079B5BDA8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56">
              <a:extLst>
                <a:ext uri="{FF2B5EF4-FFF2-40B4-BE49-F238E27FC236}">
                  <a16:creationId xmlns:a16="http://schemas.microsoft.com/office/drawing/2014/main" id="{CBFBAEAF-DB10-31EA-C084-A1AB8E1E45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3 (Age </a:t>
              </a:r>
              <a:r>
                <a:rPr kumimoji="0" lang="ja-JP" altLang="en-US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⋩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4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61686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B2B0DEF-7A90-4928-C6C9-1FA3F99E4F9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932" b="15884"/>
          <a:stretch/>
        </p:blipFill>
        <p:spPr>
          <a:xfrm>
            <a:off x="2942708" y="648882"/>
            <a:ext cx="6767837" cy="4598864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7930945" cy="4988852"/>
            <a:chOff x="2520376" y="1521804"/>
            <a:chExt cx="6207686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all-cause death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1977820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1499" y="3373714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6325065" y="2425826"/>
              <a:ext cx="2402997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= 0.001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68204" y="1658479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22.3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9.7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C8A10BE-0942-6CEB-E385-01D3800EBE2F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</a:t>
            </a:r>
            <a:r>
              <a:rPr lang="en-US" altLang="ja-JP" sz="24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1d</a:t>
            </a:r>
            <a:endParaRPr lang="ja-JP" altLang="en-US" sz="2400" b="1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054C9F9-A5DD-875B-6AEE-1469D2D86CFD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6" name="Rectangle 48">
              <a:extLst>
                <a:ext uri="{FF2B5EF4-FFF2-40B4-BE49-F238E27FC236}">
                  <a16:creationId xmlns:a16="http://schemas.microsoft.com/office/drawing/2014/main" id="{94E76BDB-F21C-75E6-7EF4-33A32357B8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56">
              <a:extLst>
                <a:ext uri="{FF2B5EF4-FFF2-40B4-BE49-F238E27FC236}">
                  <a16:creationId xmlns:a16="http://schemas.microsoft.com/office/drawing/2014/main" id="{AF829B6B-C86C-EF4F-8F35-C2CCDDBD5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1 (Age &lt;64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020765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B3F81F9-F0A8-DD69-5DED-E626383AF0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283" b="15089"/>
          <a:stretch/>
        </p:blipFill>
        <p:spPr>
          <a:xfrm>
            <a:off x="2894908" y="646946"/>
            <a:ext cx="6815638" cy="4638899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8119287" cy="4988852"/>
            <a:chOff x="2520376" y="1521804"/>
            <a:chExt cx="6355104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all-cause death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1977820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1499" y="3373714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6372107" y="1902921"/>
              <a:ext cx="2503373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&lt; 0.0001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68204" y="1658479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34.9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18.1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F7D8AA4-9104-9E4F-2513-452020BCD528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</a:t>
            </a:r>
            <a:r>
              <a:rPr lang="en-US" altLang="ja-JP" sz="24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1e</a:t>
            </a:r>
            <a:endParaRPr lang="ja-JP" altLang="en-US" sz="2400" b="1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A2241480-363C-26CB-B036-DFF9B5279E40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6" name="Rectangle 48">
              <a:extLst>
                <a:ext uri="{FF2B5EF4-FFF2-40B4-BE49-F238E27FC236}">
                  <a16:creationId xmlns:a16="http://schemas.microsoft.com/office/drawing/2014/main" id="{DD1060A2-81C1-EA07-ACEE-83044BFCA4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56">
              <a:extLst>
                <a:ext uri="{FF2B5EF4-FFF2-40B4-BE49-F238E27FC236}">
                  <a16:creationId xmlns:a16="http://schemas.microsoft.com/office/drawing/2014/main" id="{FECE583B-E241-8315-3435-1A99DD9B73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2 (Age 64-73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22840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C474ACF5-8424-14E9-A114-18CC89ECF3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136" b="15070"/>
          <a:stretch/>
        </p:blipFill>
        <p:spPr>
          <a:xfrm>
            <a:off x="2963404" y="667879"/>
            <a:ext cx="6728091" cy="4627491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FCCC84C-918A-4F7E-8B91-ADBD7CF04B9B}"/>
              </a:ext>
            </a:extLst>
          </p:cNvPr>
          <p:cNvGrpSpPr/>
          <p:nvPr/>
        </p:nvGrpSpPr>
        <p:grpSpPr>
          <a:xfrm>
            <a:off x="1943876" y="934574"/>
            <a:ext cx="7766670" cy="4988852"/>
            <a:chOff x="2520376" y="1521804"/>
            <a:chExt cx="6079105" cy="4056846"/>
          </a:xfrm>
        </p:grpSpPr>
        <p:sp>
          <p:nvSpPr>
            <p:cNvPr id="8" name="Rectangle 14">
              <a:extLst>
                <a:ext uri="{FF2B5EF4-FFF2-40B4-BE49-F238E27FC236}">
                  <a16:creationId xmlns:a16="http://schemas.microsoft.com/office/drawing/2014/main" id="{BF1F99A2-F403-4BFD-8EB7-D81084C56A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15513" y="3426667"/>
              <a:ext cx="4050627" cy="24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umulative incidence of all-cause death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9162CE5-EC47-4B82-8AE8-5DB1A0290108}"/>
                </a:ext>
              </a:extLst>
            </p:cNvPr>
            <p:cNvSpPr txBox="1"/>
            <p:nvPr/>
          </p:nvSpPr>
          <p:spPr>
            <a:xfrm>
              <a:off x="322554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C1109C6-E88B-4F31-A72B-2CC52FB6BD15}"/>
                </a:ext>
              </a:extLst>
            </p:cNvPr>
            <p:cNvSpPr txBox="1"/>
            <p:nvPr/>
          </p:nvSpPr>
          <p:spPr>
            <a:xfrm>
              <a:off x="4222476" y="5029200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D1986A-C3A1-43F8-8691-B01A5D91B944}"/>
                </a:ext>
              </a:extLst>
            </p:cNvPr>
            <p:cNvSpPr txBox="1"/>
            <p:nvPr/>
          </p:nvSpPr>
          <p:spPr>
            <a:xfrm>
              <a:off x="5211629" y="5029199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6191F21-CF9F-4BF2-B77D-59879B0839E9}"/>
                </a:ext>
              </a:extLst>
            </p:cNvPr>
            <p:cNvSpPr txBox="1"/>
            <p:nvPr/>
          </p:nvSpPr>
          <p:spPr>
            <a:xfrm>
              <a:off x="7206617" y="5021331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E55794F-F283-4D62-A148-970680712D50}"/>
                </a:ext>
              </a:extLst>
            </p:cNvPr>
            <p:cNvSpPr txBox="1"/>
            <p:nvPr/>
          </p:nvSpPr>
          <p:spPr>
            <a:xfrm>
              <a:off x="6215029" y="5021332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525AF49-8467-48E8-9C2A-CE83004A3680}"/>
                </a:ext>
              </a:extLst>
            </p:cNvPr>
            <p:cNvSpPr txBox="1"/>
            <p:nvPr/>
          </p:nvSpPr>
          <p:spPr>
            <a:xfrm>
              <a:off x="8101289" y="5029198"/>
              <a:ext cx="498192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12D579E-DAD0-4532-8F34-6E6842ECDB7C}"/>
                </a:ext>
              </a:extLst>
            </p:cNvPr>
            <p:cNvSpPr txBox="1"/>
            <p:nvPr/>
          </p:nvSpPr>
          <p:spPr>
            <a:xfrm>
              <a:off x="2904285" y="4791316"/>
              <a:ext cx="331404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DF1810-DE94-4B15-A64C-A6D1A9DA52A0}"/>
                </a:ext>
              </a:extLst>
            </p:cNvPr>
            <p:cNvSpPr txBox="1"/>
            <p:nvPr/>
          </p:nvSpPr>
          <p:spPr>
            <a:xfrm>
              <a:off x="2743575" y="2465790"/>
              <a:ext cx="663426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4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B5CB0C5-5DF0-47BE-8C3F-E3A6E6226214}"/>
                </a:ext>
              </a:extLst>
            </p:cNvPr>
            <p:cNvSpPr txBox="1"/>
            <p:nvPr/>
          </p:nvSpPr>
          <p:spPr>
            <a:xfrm>
              <a:off x="2795855" y="3642959"/>
              <a:ext cx="556028" cy="30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0.2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AAF7A5B-AB72-4C2B-9847-2D1BADA72F7D}"/>
                </a:ext>
              </a:extLst>
            </p:cNvPr>
            <p:cNvSpPr txBox="1"/>
            <p:nvPr/>
          </p:nvSpPr>
          <p:spPr>
            <a:xfrm>
              <a:off x="5603596" y="1733156"/>
              <a:ext cx="2503373" cy="325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verall log-rank p &lt; 0.0001</a:t>
              </a:r>
              <a:endParaRPr lang="ja-JP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4">
              <a:extLst>
                <a:ext uri="{FF2B5EF4-FFF2-40B4-BE49-F238E27FC236}">
                  <a16:creationId xmlns:a16="http://schemas.microsoft.com/office/drawing/2014/main" id="{D3BDB2E9-DF2B-4047-BE85-C07429E23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5012" y="5270873"/>
              <a:ext cx="142096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in Years</a:t>
              </a:r>
              <a:endParaRPr kumimoji="0" lang="ja-JP" altLang="ja-JP" sz="2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793CFB4-6FC0-486C-AA37-74B629BDB4A5}"/>
              </a:ext>
            </a:extLst>
          </p:cNvPr>
          <p:cNvGrpSpPr/>
          <p:nvPr/>
        </p:nvGrpSpPr>
        <p:grpSpPr>
          <a:xfrm>
            <a:off x="3219348" y="1617321"/>
            <a:ext cx="3453788" cy="1137820"/>
            <a:chOff x="3682509" y="3752233"/>
            <a:chExt cx="3453788" cy="1137820"/>
          </a:xfrm>
        </p:grpSpPr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2F52DF5-4A6B-4DDC-9AD4-CFDD6663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3"/>
              <a:ext cx="3453788" cy="1137820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6">
              <a:extLst>
                <a:ext uri="{FF2B5EF4-FFF2-40B4-BE49-F238E27FC236}">
                  <a16:creationId xmlns:a16="http://schemas.microsoft.com/office/drawing/2014/main" id="{CDEEB86D-D449-4265-9483-0C1B433BA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3903986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ow ASMI Group  52.5%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4">
              <a:extLst>
                <a:ext uri="{FF2B5EF4-FFF2-40B4-BE49-F238E27FC236}">
                  <a16:creationId xmlns:a16="http://schemas.microsoft.com/office/drawing/2014/main" id="{E1770A2B-AFED-4BFA-B108-6A6085E7C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4215" y="4386259"/>
              <a:ext cx="27620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igh ASMI Group  24.1%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51">
              <a:extLst>
                <a:ext uri="{FF2B5EF4-FFF2-40B4-BE49-F238E27FC236}">
                  <a16:creationId xmlns:a16="http://schemas.microsoft.com/office/drawing/2014/main" id="{D446440B-EFC3-402F-A6A9-917F85E807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307" y="4521516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406FD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>
              <a:extLst>
                <a:ext uri="{FF2B5EF4-FFF2-40B4-BE49-F238E27FC236}">
                  <a16:creationId xmlns:a16="http://schemas.microsoft.com/office/drawing/2014/main" id="{240376EF-63DA-46C3-9365-91C0AC771E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4307" y="4085688"/>
              <a:ext cx="400068" cy="0"/>
            </a:xfrm>
            <a:prstGeom prst="line">
              <a:avLst/>
            </a:prstGeom>
            <a:noFill/>
            <a:ln w="57150" cap="flat">
              <a:solidFill>
                <a:srgbClr val="D54857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D19E6B8-FEED-A0E2-436E-A6F86632C0FD}"/>
              </a:ext>
            </a:extLst>
          </p:cNvPr>
          <p:cNvSpPr txBox="1"/>
          <p:nvPr/>
        </p:nvSpPr>
        <p:spPr>
          <a:xfrm>
            <a:off x="2222262" y="685038"/>
            <a:ext cx="847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0.6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674A08E-FD14-3BC1-A765-B7A4486837BF}"/>
              </a:ext>
            </a:extLst>
          </p:cNvPr>
          <p:cNvSpPr txBox="1"/>
          <p:nvPr/>
        </p:nvSpPr>
        <p:spPr>
          <a:xfrm>
            <a:off x="523125" y="265635"/>
            <a:ext cx="60938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</a:t>
            </a:r>
            <a:r>
              <a:rPr lang="en-US" altLang="ja-JP" sz="24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1f</a:t>
            </a:r>
            <a:endParaRPr lang="ja-JP" altLang="en-US" sz="2400" b="1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0DB9FA6B-293D-7811-124B-0CB8FE71C3BD}"/>
              </a:ext>
            </a:extLst>
          </p:cNvPr>
          <p:cNvGrpSpPr/>
          <p:nvPr/>
        </p:nvGrpSpPr>
        <p:grpSpPr>
          <a:xfrm>
            <a:off x="3392227" y="789090"/>
            <a:ext cx="3521340" cy="907235"/>
            <a:chOff x="3682509" y="3752236"/>
            <a:chExt cx="3453788" cy="2586244"/>
          </a:xfrm>
        </p:grpSpPr>
        <p:sp>
          <p:nvSpPr>
            <p:cNvPr id="7" name="Rectangle 48">
              <a:extLst>
                <a:ext uri="{FF2B5EF4-FFF2-40B4-BE49-F238E27FC236}">
                  <a16:creationId xmlns:a16="http://schemas.microsoft.com/office/drawing/2014/main" id="{AE1F9048-7BDA-D817-7EB2-E39FB92EA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509" y="3752236"/>
              <a:ext cx="3453788" cy="1137821"/>
            </a:xfrm>
            <a:prstGeom prst="rect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56">
              <a:extLst>
                <a:ext uri="{FF2B5EF4-FFF2-40B4-BE49-F238E27FC236}">
                  <a16:creationId xmlns:a16="http://schemas.microsoft.com/office/drawing/2014/main" id="{7F14961D-3175-5092-8551-79998C2E7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362" y="3881831"/>
              <a:ext cx="2762083" cy="2456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20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ertile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3 (Age </a:t>
              </a:r>
              <a:r>
                <a:rPr kumimoji="0" lang="ja-JP" altLang="en-US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⋩</a:t>
              </a:r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4 years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46567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4</TotalTime>
  <Words>254</Words>
  <Application>Microsoft Office PowerPoint</Application>
  <PresentationFormat>ワイド画面</PresentationFormat>
  <Paragraphs>97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尾 亮太</dc:creator>
  <cp:lastModifiedBy>西尾 亮太</cp:lastModifiedBy>
  <cp:revision>15</cp:revision>
  <dcterms:created xsi:type="dcterms:W3CDTF">2022-04-06T05:26:07Z</dcterms:created>
  <dcterms:modified xsi:type="dcterms:W3CDTF">2022-11-19T08:23:46Z</dcterms:modified>
</cp:coreProperties>
</file>